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0" r:id="rId2"/>
  </p:sldIdLst>
  <p:sldSz cx="6858000" cy="9906000" type="A4"/>
  <p:notesSz cx="67833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5B1"/>
    <a:srgbClr val="E1DEC1"/>
    <a:srgbClr val="47BF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18" autoAdjust="0"/>
    <p:restoredTop sz="96412" autoAdjust="0"/>
  </p:normalViewPr>
  <p:slideViewPr>
    <p:cSldViewPr>
      <p:cViewPr varScale="1">
        <p:scale>
          <a:sx n="92" d="100"/>
          <a:sy n="92" d="100"/>
        </p:scale>
        <p:origin x="-3120" y="-12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946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2350" y="0"/>
            <a:ext cx="293946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509BA1-371D-41D3-BAC8-E85FA15C101D}" type="datetimeFigureOut">
              <a:rPr lang="en-AU" smtClean="0"/>
              <a:t>14/03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339" y="4715153"/>
            <a:ext cx="542671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3946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2350" y="9428583"/>
            <a:ext cx="293946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BD5C5-041D-4AE9-8052-73C2E7B8D34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43928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5340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1545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297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5628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5875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176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985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51686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2283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9609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3909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CDC39-7138-4987-B091-50CEB1E324D2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1/3/1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509BE-5D86-4AAD-A019-4E39F200EBE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5619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263468" y="1424457"/>
            <a:ext cx="6251749" cy="6048823"/>
            <a:chOff x="263468" y="272481"/>
            <a:chExt cx="6251749" cy="6048823"/>
          </a:xfrm>
        </p:grpSpPr>
        <p:sp>
          <p:nvSpPr>
            <p:cNvPr id="2" name="TextBox 1"/>
            <p:cNvSpPr txBox="1"/>
            <p:nvPr/>
          </p:nvSpPr>
          <p:spPr>
            <a:xfrm>
              <a:off x="2856574" y="563332"/>
              <a:ext cx="1473799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expression 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59678" y="563331"/>
              <a:ext cx="1598816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ression 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-393334" y="929283"/>
              <a:ext cx="1598816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P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-59670" y="3218358"/>
              <a:ext cx="931488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-393334" y="4817715"/>
              <a:ext cx="1598816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P+DAPI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813166" y="563330"/>
              <a:ext cx="1473799" cy="285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464632" y="848543"/>
              <a:ext cx="6050585" cy="5472761"/>
              <a:chOff x="464632" y="848543"/>
              <a:chExt cx="6050585" cy="5472761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464632" y="848543"/>
                <a:ext cx="6016874" cy="5472761"/>
                <a:chOff x="464632" y="848543"/>
                <a:chExt cx="6016874" cy="5472761"/>
              </a:xfrm>
            </p:grpSpPr>
            <p:grpSp>
              <p:nvGrpSpPr>
                <p:cNvPr id="15" name="Group 14"/>
                <p:cNvGrpSpPr/>
                <p:nvPr/>
              </p:nvGrpSpPr>
              <p:grpSpPr>
                <a:xfrm>
                  <a:off x="485492" y="848543"/>
                  <a:ext cx="5996014" cy="5472761"/>
                  <a:chOff x="485492" y="848543"/>
                  <a:chExt cx="5996014" cy="5472761"/>
                </a:xfrm>
              </p:grpSpPr>
              <p:pic>
                <p:nvPicPr>
                  <p:cNvPr id="104" name="Picture 7"/>
                  <p:cNvPicPr preferRelativeResize="0">
                    <a:picLocks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85492" y="848543"/>
                    <a:ext cx="1980000" cy="1800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05" name="Picture 18"/>
                  <p:cNvPicPr preferRelativeResize="0">
                    <a:picLocks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492896" y="848544"/>
                    <a:ext cx="1980000" cy="1800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" name="Picture 5"/>
                  <p:cNvPicPr preferRelativeResize="0">
                    <a:picLocks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92896" y="2681014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7" name="Picture 6"/>
                  <p:cNvPicPr preferRelativeResize="0">
                    <a:picLocks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95284" y="4521304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10" name="Picture 9"/>
                  <p:cNvPicPr preferRelativeResize="0">
                    <a:picLocks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8597" y="4516404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/>
                  <p:cNvPicPr preferRelativeResize="0">
                    <a:picLocks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5643" y="2676114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12" name="Picture 11"/>
                  <p:cNvPicPr preferRelativeResize="0">
                    <a:picLocks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501506" y="4516404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/>
                  <p:cNvPicPr preferRelativeResize="0">
                    <a:picLocks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500155" y="2682040"/>
                    <a:ext cx="1980000" cy="1800000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/>
                  <p:cNvPicPr preferRelativeResize="0">
                    <a:picLocks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496438" y="848544"/>
                    <a:ext cx="1980000" cy="18000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50" name="TextBox 49"/>
                <p:cNvSpPr txBox="1"/>
                <p:nvPr/>
              </p:nvSpPr>
              <p:spPr>
                <a:xfrm>
                  <a:off x="464632" y="892719"/>
                  <a:ext cx="3117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A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 flipH="1">
                  <a:off x="476672" y="2741329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D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 flipH="1">
                  <a:off x="476672" y="452774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G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 flipH="1">
                  <a:off x="2492896" y="848544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B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 flipH="1">
                  <a:off x="2468597" y="2717356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E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 flipH="1">
                  <a:off x="2495284" y="4516404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H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4509120" y="848544"/>
                  <a:ext cx="3117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C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 flipH="1">
                  <a:off x="4509120" y="270100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 flipH="1">
                  <a:off x="4512463" y="4527747"/>
                  <a:ext cx="43204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I</a:t>
                  </a:r>
                  <a:endParaRPr lang="zh-CN" altLang="en-US" sz="1400" b="1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1916454" y="2329224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25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5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 smtClean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60" name="Group 59"/>
              <p:cNvGrpSpPr/>
              <p:nvPr/>
            </p:nvGrpSpPr>
            <p:grpSpPr>
              <a:xfrm>
                <a:off x="3850846" y="2338232"/>
                <a:ext cx="610153" cy="369332"/>
                <a:chOff x="1006590" y="5313040"/>
                <a:chExt cx="592585" cy="369332"/>
              </a:xfrm>
            </p:grpSpPr>
            <p:cxnSp>
              <p:nvCxnSpPr>
                <p:cNvPr id="61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61"/>
                <p:cNvSpPr txBox="1"/>
                <p:nvPr/>
              </p:nvSpPr>
              <p:spPr>
                <a:xfrm>
                  <a:off x="1006590" y="5313040"/>
                  <a:ext cx="59258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ctr"/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63" name="Group 62"/>
              <p:cNvGrpSpPr/>
              <p:nvPr/>
            </p:nvGrpSpPr>
            <p:grpSpPr>
              <a:xfrm>
                <a:off x="5871353" y="2338232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64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TextBox 64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66" name="Group 65"/>
              <p:cNvGrpSpPr/>
              <p:nvPr/>
            </p:nvGrpSpPr>
            <p:grpSpPr>
              <a:xfrm>
                <a:off x="1869014" y="4151904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67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67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69" name="Group 68"/>
              <p:cNvGrpSpPr/>
              <p:nvPr/>
            </p:nvGrpSpPr>
            <p:grpSpPr>
              <a:xfrm>
                <a:off x="3884107" y="4186120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70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2" name="Group 71"/>
              <p:cNvGrpSpPr/>
              <p:nvPr/>
            </p:nvGrpSpPr>
            <p:grpSpPr>
              <a:xfrm>
                <a:off x="5871353" y="4186120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73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5" name="Group 74"/>
              <p:cNvGrpSpPr/>
              <p:nvPr/>
            </p:nvGrpSpPr>
            <p:grpSpPr>
              <a:xfrm>
                <a:off x="1876500" y="5987298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76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76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8" name="Group 77"/>
              <p:cNvGrpSpPr/>
              <p:nvPr/>
            </p:nvGrpSpPr>
            <p:grpSpPr>
              <a:xfrm>
                <a:off x="3917818" y="5987298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79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TextBox 79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1" name="Group 80"/>
              <p:cNvGrpSpPr/>
              <p:nvPr/>
            </p:nvGrpSpPr>
            <p:grpSpPr>
              <a:xfrm>
                <a:off x="5905064" y="5987298"/>
                <a:ext cx="610153" cy="239840"/>
                <a:chOff x="1006590" y="5313040"/>
                <a:chExt cx="592585" cy="239840"/>
              </a:xfrm>
            </p:grpSpPr>
            <p:cxnSp>
              <p:nvCxnSpPr>
                <p:cNvPr id="82" name="直接连接符 27"/>
                <p:cNvCxnSpPr/>
                <p:nvPr/>
              </p:nvCxnSpPr>
              <p:spPr>
                <a:xfrm>
                  <a:off x="1152724" y="5552880"/>
                  <a:ext cx="365800" cy="0"/>
                </a:xfrm>
                <a:prstGeom prst="line">
                  <a:avLst/>
                </a:prstGeom>
                <a:ln w="222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3" name="TextBox 82"/>
                <p:cNvSpPr txBox="1"/>
                <p:nvPr/>
              </p:nvSpPr>
              <p:spPr>
                <a:xfrm>
                  <a:off x="1006590" y="5313040"/>
                  <a:ext cx="59258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dirty="0" smtClean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50 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Symbol" panose="05050102010706020507" pitchFamily="18" charset="2"/>
                      <a:cs typeface="Arial" pitchFamily="34" charset="0"/>
                    </a:rPr>
                    <a:t>m</a:t>
                  </a:r>
                  <a:r>
                    <a:rPr lang="en-US" altLang="zh-CN" sz="900" dirty="0">
                      <a:solidFill>
                        <a:schemeClr val="bg1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endParaRPr lang="zh-CN" altLang="en-US" sz="900" dirty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sp>
        <p:nvSpPr>
          <p:cNvPr id="59" name="TextBox 58"/>
          <p:cNvSpPr txBox="1"/>
          <p:nvPr/>
        </p:nvSpPr>
        <p:spPr>
          <a:xfrm>
            <a:off x="4653136" y="9438982"/>
            <a:ext cx="2088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600" dirty="0">
                <a:latin typeface="Arial" panose="020B0604020202020204" pitchFamily="34" charset="0"/>
                <a:cs typeface="Arial" panose="020B0604020202020204" pitchFamily="34" charset="0"/>
              </a:rPr>
              <a:t>Sun et al., </a:t>
            </a:r>
            <a:r>
              <a:rPr lang="en-AU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AU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2603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968</TotalTime>
  <Words>42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Company>The University of Adelai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1151335</dc:creator>
  <cp:lastModifiedBy>GSABORDO</cp:lastModifiedBy>
  <cp:revision>415</cp:revision>
  <cp:lastPrinted>2020-07-30T01:28:56Z</cp:lastPrinted>
  <dcterms:created xsi:type="dcterms:W3CDTF">2014-10-19T02:34:47Z</dcterms:created>
  <dcterms:modified xsi:type="dcterms:W3CDTF">2021-03-14T01:36:22Z</dcterms:modified>
</cp:coreProperties>
</file>